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451" autoAdjust="0"/>
  </p:normalViewPr>
  <p:slideViewPr>
    <p:cSldViewPr snapToGrid="0">
      <p:cViewPr varScale="1">
        <p:scale>
          <a:sx n="103" d="100"/>
          <a:sy n="103" d="100"/>
        </p:scale>
        <p:origin x="792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431610-DC20-4718-8D6B-14D2D8F64A8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78E481C-E5AD-4AF4-A723-27C93146677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7CF9544-EB6C-4696-A20D-6644990400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8D8B90-55EE-4E00-8652-295A34281575}" type="datetimeFigureOut">
              <a:rPr lang="en-GB" smtClean="0"/>
              <a:t>06/09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D64333B-4CEB-47AA-BCB5-F99EA54466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855EAE0-F851-46B5-A0E0-9139D7D7CB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0506E5-EE7A-4B21-825C-95C750D9D2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130691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2A1C04-A5D2-4AC0-8191-A1F579DE387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E748C8A-29C0-4762-A677-6036907551E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C2B477E-8059-46EC-91FC-926412CACA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8D8B90-55EE-4E00-8652-295A34281575}" type="datetimeFigureOut">
              <a:rPr lang="en-GB" smtClean="0"/>
              <a:t>06/09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6B676F3-AEFD-4205-B8CE-65DC3D34B5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FE91ED2-B4F9-4B99-BC51-F60AABC203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0506E5-EE7A-4B21-825C-95C750D9D2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371695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303A043-4BD0-422C-8834-982D3B835AA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67953C9-470D-429C-8FA3-D026BD6424F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A2BDE52-5229-4A40-983A-9D85ED7080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8D8B90-55EE-4E00-8652-295A34281575}" type="datetimeFigureOut">
              <a:rPr lang="en-GB" smtClean="0"/>
              <a:t>06/09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57ED508-C5F3-47CE-BBD1-0E6A3B99C8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7604DBF-CE7C-49AB-8B2E-DFFD9BA0CA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0506E5-EE7A-4B21-825C-95C750D9D2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469565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5D6060-B3DD-4B14-9ECD-37A4D58237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78EBC7B-E788-45F9-A36A-40A04CC8A39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6A72CA5-26A4-4255-971D-59B2B86C64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8D8B90-55EE-4E00-8652-295A34281575}" type="datetimeFigureOut">
              <a:rPr lang="en-GB" smtClean="0"/>
              <a:t>06/09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B5BFFE8-E2C5-493B-BE8D-26565EA69F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CC42F12-0340-4C6E-8D84-F85665E38E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0506E5-EE7A-4B21-825C-95C750D9D2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214585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553B3F-8633-4ACF-B7F2-BCEA29DBE0E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8F7FE1B-C161-4CC8-89CD-B287224B5BD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99D6104-B795-4A2A-B686-3154C3D2E9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8D8B90-55EE-4E00-8652-295A34281575}" type="datetimeFigureOut">
              <a:rPr lang="en-GB" smtClean="0"/>
              <a:t>06/09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2715068-8EA9-4038-97D2-87B84C3AF5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493F1C5-88BF-4E5E-8BCE-248297E660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0506E5-EE7A-4B21-825C-95C750D9D2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054041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019E8E0-95A6-49A7-BAAF-3586B65ABC3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334E509-54F1-4614-A2D8-AEA98DE8A3A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69A7FC8-F13A-4687-9416-BB2D4FC7382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91A8826-7474-4E63-840B-00D3749C51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8D8B90-55EE-4E00-8652-295A34281575}" type="datetimeFigureOut">
              <a:rPr lang="en-GB" smtClean="0"/>
              <a:t>06/09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4869ADC-11AB-42AF-8E81-5DC35950FF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6A4DD67-5C81-4050-87EE-1ECD9C3F76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0506E5-EE7A-4B21-825C-95C750D9D2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326119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CE61B7-432A-4DCD-8265-96B7FEE51B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1F401D6-3659-4CE0-B6FA-9128A67B1B4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4D0119F-7A1B-4D10-9781-3C5EA167B0C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9BE9430-B365-4DD1-8D5B-E62A9609752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C8812A1-C66D-46A9-9953-992194777E2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E2B1D55-A05B-4B20-9410-57DF22A686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8D8B90-55EE-4E00-8652-295A34281575}" type="datetimeFigureOut">
              <a:rPr lang="en-GB" smtClean="0"/>
              <a:t>06/09/2022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A451805-A9BB-408E-9C8D-370F608E1D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C471EF3-2989-4543-A17C-37F6BBE8E8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0506E5-EE7A-4B21-825C-95C750D9D2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553441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DF798B-887F-4186-BAF6-06BD5C01482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2A2C41B-8248-4ADA-8BF5-39F90FD2D5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8D8B90-55EE-4E00-8652-295A34281575}" type="datetimeFigureOut">
              <a:rPr lang="en-GB" smtClean="0"/>
              <a:t>06/09/2022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F0E1161-C2EE-4CCA-AEE5-AE9F60F312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8B4F643-4735-47F4-923B-1A2CCDA945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0506E5-EE7A-4B21-825C-95C750D9D2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576632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61FD339-3795-45C4-9D94-3D727AD945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8D8B90-55EE-4E00-8652-295A34281575}" type="datetimeFigureOut">
              <a:rPr lang="en-GB" smtClean="0"/>
              <a:t>06/09/2022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9B5BE90-F5D2-4FAC-A705-433756D384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B313BD6-69F1-48CC-87F5-FC43164385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0506E5-EE7A-4B21-825C-95C750D9D2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210052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D2D3F6A-06FE-497F-B05D-C3C9A70700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8538ECA-B591-4F29-BA96-90FD44D43B8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29D58E0-4D9F-4A13-A147-8F597ACF300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D13D00F-CE10-40BD-ACAC-0D7043B52E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8D8B90-55EE-4E00-8652-295A34281575}" type="datetimeFigureOut">
              <a:rPr lang="en-GB" smtClean="0"/>
              <a:t>06/09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E726569-0B2A-4B48-A9FB-09488D91B6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91A475B-7887-4F1C-A506-52545E258C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0506E5-EE7A-4B21-825C-95C750D9D2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154721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4E2CFC-CA80-4A47-9908-21E97D4E650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FCE45D4-A92A-452B-8B90-95FB3FE6B3A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8B3B425-41D0-4BDA-9D89-70D1D921235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61BF7FB-D321-4DBE-B30A-BB6A964795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8D8B90-55EE-4E00-8652-295A34281575}" type="datetimeFigureOut">
              <a:rPr lang="en-GB" smtClean="0"/>
              <a:t>06/09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166C368-92F6-4B18-A0FA-7BE9FAFD49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6013F66-EF91-4E99-97D6-386A370419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0506E5-EE7A-4B21-825C-95C750D9D2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602380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C1B8E5E-FD49-4E55-BE60-6DAF00364FE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3317C34-5035-4622-8351-52C10794EDA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1F2710F-55EA-4676-A424-204E1A54C41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8D8B90-55EE-4E00-8652-295A34281575}" type="datetimeFigureOut">
              <a:rPr lang="en-GB" smtClean="0"/>
              <a:t>06/09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EEEB441-6E6A-4E34-BC19-36EC52F6662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C2F0369-9A35-4B4F-A75C-5A28C4E63BB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0506E5-EE7A-4B21-825C-95C750D9D2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793361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5B344841-D625-489E-970E-5961DDF66A6C}"/>
              </a:ext>
            </a:extLst>
          </p:cNvPr>
          <p:cNvSpPr/>
          <p:nvPr/>
        </p:nvSpPr>
        <p:spPr>
          <a:xfrm>
            <a:off x="1984761" y="5461101"/>
            <a:ext cx="7516290" cy="5078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900" b="1" dirty="0">
                <a:latin typeface="Palatino Linotype" panose="02040502050505030304" pitchFamily="18" charset="0"/>
              </a:rPr>
              <a:t>Figure S1:</a:t>
            </a:r>
            <a:r>
              <a:rPr lang="en-US" sz="900" dirty="0">
                <a:latin typeface="Palatino Linotype" panose="02040502050505030304" pitchFamily="18" charset="0"/>
              </a:rPr>
              <a:t> Colony PCR of deletion mutants of the Gpl1−Gih35−Wdr83 complex. The PCR products correspond to wild type alleles of </a:t>
            </a:r>
            <a:r>
              <a:rPr lang="en-US" sz="900" i="1" dirty="0">
                <a:latin typeface="Palatino Linotype" panose="02040502050505030304" pitchFamily="18" charset="0"/>
              </a:rPr>
              <a:t>gpl1</a:t>
            </a:r>
            <a:r>
              <a:rPr lang="en-US" sz="900" dirty="0">
                <a:latin typeface="Palatino Linotype" panose="02040502050505030304" pitchFamily="18" charset="0"/>
              </a:rPr>
              <a:t> (1622 bp), </a:t>
            </a:r>
            <a:r>
              <a:rPr lang="en-US" sz="900" i="1" dirty="0">
                <a:latin typeface="Palatino Linotype" panose="02040502050505030304" pitchFamily="18" charset="0"/>
              </a:rPr>
              <a:t>gih35</a:t>
            </a:r>
            <a:r>
              <a:rPr lang="en-US" sz="900" dirty="0">
                <a:latin typeface="Palatino Linotype" panose="02040502050505030304" pitchFamily="18" charset="0"/>
              </a:rPr>
              <a:t> (2310 bp) and </a:t>
            </a:r>
            <a:r>
              <a:rPr lang="en-US" sz="900" i="1" dirty="0">
                <a:latin typeface="Palatino Linotype" panose="02040502050505030304" pitchFamily="18" charset="0"/>
              </a:rPr>
              <a:t>wdr83</a:t>
            </a:r>
            <a:r>
              <a:rPr lang="en-US" sz="900" dirty="0">
                <a:latin typeface="Palatino Linotype" panose="02040502050505030304" pitchFamily="18" charset="0"/>
              </a:rPr>
              <a:t> (1042), or to the </a:t>
            </a:r>
            <a:r>
              <a:rPr lang="en-US" sz="900" i="1" dirty="0">
                <a:latin typeface="Palatino Linotype" panose="02040502050505030304" pitchFamily="18" charset="0"/>
              </a:rPr>
              <a:t>up</a:t>
            </a:r>
            <a:r>
              <a:rPr lang="en-US" sz="900" dirty="0">
                <a:latin typeface="Palatino Linotype" panose="02040502050505030304" pitchFamily="18" charset="0"/>
              </a:rPr>
              <a:t>-check and </a:t>
            </a:r>
            <a:r>
              <a:rPr lang="en-US" sz="900" i="1" dirty="0" err="1">
                <a:latin typeface="Palatino Linotype" panose="02040502050505030304" pitchFamily="18" charset="0"/>
              </a:rPr>
              <a:t>dw</a:t>
            </a:r>
            <a:r>
              <a:rPr lang="en-US" sz="900" dirty="0">
                <a:latin typeface="Palatino Linotype" panose="02040502050505030304" pitchFamily="18" charset="0"/>
              </a:rPr>
              <a:t>-check regions of deletions of </a:t>
            </a:r>
            <a:r>
              <a:rPr lang="en-US" sz="900" i="1" dirty="0">
                <a:latin typeface="Palatino Linotype" panose="02040502050505030304" pitchFamily="18" charset="0"/>
              </a:rPr>
              <a:t>gpl1</a:t>
            </a:r>
            <a:r>
              <a:rPr lang="en-US" sz="900" dirty="0">
                <a:latin typeface="Palatino Linotype" panose="02040502050505030304" pitchFamily="18" charset="0"/>
              </a:rPr>
              <a:t> (904 bp and 569 bp), </a:t>
            </a:r>
            <a:r>
              <a:rPr lang="en-US" sz="900" i="1" dirty="0">
                <a:latin typeface="Palatino Linotype" panose="02040502050505030304" pitchFamily="18" charset="0"/>
              </a:rPr>
              <a:t>gih35</a:t>
            </a:r>
            <a:r>
              <a:rPr lang="en-US" sz="900" dirty="0">
                <a:latin typeface="Palatino Linotype" panose="02040502050505030304" pitchFamily="18" charset="0"/>
              </a:rPr>
              <a:t> (925 bp and 616 bp) and </a:t>
            </a:r>
            <a:r>
              <a:rPr lang="en-US" sz="900" i="1" dirty="0">
                <a:latin typeface="Palatino Linotype" panose="02040502050505030304" pitchFamily="18" charset="0"/>
              </a:rPr>
              <a:t>wdr83</a:t>
            </a:r>
            <a:r>
              <a:rPr lang="en-US" sz="900" dirty="0">
                <a:latin typeface="Palatino Linotype" panose="02040502050505030304" pitchFamily="18" charset="0"/>
              </a:rPr>
              <a:t> (983 bp and 616 bp).</a:t>
            </a:r>
            <a:endParaRPr lang="en-GB" sz="900" dirty="0">
              <a:latin typeface="Palatino Linotype" panose="02040502050505030304" pitchFamily="18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1BE0B359-280D-469F-BAD2-09479FE1770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84761" y="149961"/>
            <a:ext cx="7516290" cy="51013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041481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0</TotalTime>
  <Words>76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ubos Cipak</dc:creator>
  <cp:lastModifiedBy>Lubos Cipak</cp:lastModifiedBy>
  <cp:revision>25</cp:revision>
  <cp:lastPrinted>2022-03-15T13:10:27Z</cp:lastPrinted>
  <dcterms:created xsi:type="dcterms:W3CDTF">2022-03-15T10:44:31Z</dcterms:created>
  <dcterms:modified xsi:type="dcterms:W3CDTF">2022-09-06T08:36:57Z</dcterms:modified>
</cp:coreProperties>
</file>